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66" autoAdjust="0"/>
    <p:restoredTop sz="94660"/>
  </p:normalViewPr>
  <p:slideViewPr>
    <p:cSldViewPr snapToGrid="0">
      <p:cViewPr varScale="1">
        <p:scale>
          <a:sx n="62" d="100"/>
          <a:sy n="62" d="100"/>
        </p:scale>
        <p:origin x="19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634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216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8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310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024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741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812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030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54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299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576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102962-B0C7-47F1-AD92-29140DB52D2D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88BF9C-232B-45A0-A1BE-043AB26D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151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16">
            <a:extLst>
              <a:ext uri="{FF2B5EF4-FFF2-40B4-BE49-F238E27FC236}">
                <a16:creationId xmlns:a16="http://schemas.microsoft.com/office/drawing/2014/main" id="{371CBFE6-5E46-4E23-B806-69BE8F9D6870}"/>
              </a:ext>
            </a:extLst>
          </p:cNvPr>
          <p:cNvSpPr txBox="1"/>
          <p:nvPr/>
        </p:nvSpPr>
        <p:spPr>
          <a:xfrm>
            <a:off x="102139" y="117122"/>
            <a:ext cx="24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ZoneTexte 16">
            <a:extLst>
              <a:ext uri="{FF2B5EF4-FFF2-40B4-BE49-F238E27FC236}">
                <a16:creationId xmlns:a16="http://schemas.microsoft.com/office/drawing/2014/main" id="{371CBFE6-5E46-4E23-B806-69BE8F9D6870}"/>
              </a:ext>
            </a:extLst>
          </p:cNvPr>
          <p:cNvSpPr txBox="1"/>
          <p:nvPr/>
        </p:nvSpPr>
        <p:spPr>
          <a:xfrm>
            <a:off x="95308" y="6317050"/>
            <a:ext cx="250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308" y="6721113"/>
            <a:ext cx="9245424" cy="5149417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309" y="486911"/>
            <a:ext cx="9245424" cy="5876925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6F982671-1BA1-444E-95AF-432D597B6024}"/>
              </a:ext>
            </a:extLst>
          </p:cNvPr>
          <p:cNvSpPr/>
          <p:nvPr/>
        </p:nvSpPr>
        <p:spPr>
          <a:xfrm>
            <a:off x="102139" y="11870530"/>
            <a:ext cx="9361175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S4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hesion and biofilm formation of the 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3 </a:t>
            </a:r>
            <a:r>
              <a:rPr lang="fr-FR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jejuni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ins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the BioFilm Ring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®. </a:t>
            </a:r>
          </a:p>
          <a:p>
            <a:pPr algn="just"/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Adhesion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h of contact to an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ert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face in water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</a:t>
            </a:r>
            <a:r>
              <a:rPr lang="fr-F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fc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um. (B) Biofilm formation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2 h of incubation in 10X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lut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HI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her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ror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correspond to the relative standard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viation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d line separates strains with low or no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hesion or low or no biofilm former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ΔBFI &lt; 8)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the ones with high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hesion or high biofilm former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ΔBFI ≥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). Positive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negative strain controls were used in each assay, Bf and Camp052 respectively. 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776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0</Words>
  <Application>Microsoft Office PowerPoint</Application>
  <PresentationFormat>A3 Paper (297x420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T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gane Nennig</dc:creator>
  <cp:lastModifiedBy>Morgane Nennig</cp:lastModifiedBy>
  <cp:revision>8</cp:revision>
  <dcterms:created xsi:type="dcterms:W3CDTF">2022-02-04T12:42:40Z</dcterms:created>
  <dcterms:modified xsi:type="dcterms:W3CDTF">2022-03-01T06:52:03Z</dcterms:modified>
</cp:coreProperties>
</file>